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0021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42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9A1E39-BA89-273B-A204-B38CABD030A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6EEB02E-B1E2-8B76-BCC7-231915A4B90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1C160E8-5AA4-C4A2-F2F8-203E029B57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DD43C9-76E1-D61F-05A6-3BBE3D8E36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84B915-14C2-4627-523D-C68EE8493B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11995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693B2F-CF3F-7F87-980A-4DAA3022F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34A6D58-5F9C-114E-7ACF-63135E6318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0595DF7-D8E9-E08A-7DDC-FD8099EB2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27C504-3CD9-DC1A-CFDC-717CF41030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CBE106-CE13-F207-77F7-BD86FA3517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0463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648794-FD49-D328-DB35-9038F2C73F9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DA8EE66-2E5D-D344-3763-832AAD24800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0D894A-620F-CF36-CF49-BBE6F70917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B02128-9EBB-20DA-36AB-C6E0F1724F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3E19AC-E67E-B544-2C41-9C9BE95B91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9757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290548-8096-8121-49D0-439B732393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7536BC-0931-EB97-E16A-7E9FC922AC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E9EBAE-68D8-E55D-BE59-5FF2059E66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34B1F1-55A7-F3A9-60F2-B64452827F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8CB4A40-A97D-0E90-E8E0-704DD5D951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99371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06C42-EAEF-63AF-2400-33000C02FB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4F937BF-9CB1-B08C-336E-378678CD2E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4C7AB4-7272-536E-3CF2-6F9414D96D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34FFBB-F536-37EB-CC0B-116AFACD89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7D4AE0-F167-7B21-FDB4-B92F66A3A2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68037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CB70F6-AAA7-AE18-6F17-6BB70F0274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B75BEA0-A507-803C-374F-7A16A55A840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FA6EB0A-7E90-FD49-0C80-CD910A5F26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63E6F7-AABF-C75B-E98D-62BFCE272A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FA69E1-DA7C-5B13-C415-20E156431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5D4550-9CBC-AEED-53D5-AAD0A9D24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1829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C6CAF2-4687-AB9C-3A73-4FFB6B3BCC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69C99A-0E87-81CE-66DC-CFF406E6F7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C0FDA6B-E257-CAC6-1DF8-FCDA63813D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66686D8-0BC3-02A4-499D-FC5BDCDBCB8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F345FC4-4282-83DA-88EC-3A616C9FA9D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0AFEA6B-1B1E-5DA0-AB59-93E260B7C8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743BB2B-21A8-E426-42F4-357764B3DC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E7EF650-C634-7DD8-AE8F-F0D08D4C56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19329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64DC88-CE0B-4FA2-43E1-48BD5CB7D2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C20D58F-4FAD-F266-96D7-30BA981462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FD32070-2F46-2AD8-9B4D-584434CCA8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6F2B0B9-D2D4-16BF-D294-0E45262BEFB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9286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95B2B2C-D98A-64A7-813F-595B0B56B9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9F45CAD-75AC-D362-FBAD-34D940E945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781A6D7-1346-8A1E-3908-AE3D6FD3B1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2527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3DA1E7-0AA3-5F9D-359F-0A3A809650B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4F7C00-68E6-BFEA-2867-B38FF0CDB38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981F58E-5916-5A07-CC61-FE23A92EDC7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7CBD6FE-2E7B-3F4F-BBAF-2347C2E14A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84DE5D-FB29-C1FF-8B56-F6C1E49905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B4CE222-AD98-0605-19D6-C6189A46B6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58807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EF7D6F-B3D2-4AF8-0201-2BB1D8B908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9D06D0E-6D78-D168-0962-C34147A7CEE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4E36721-34B8-5C58-8A52-304B914483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2EEB8D3-9069-A85E-F3D6-3B149F511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EED885C-A6D7-6D43-B4C1-904EBB3167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CAAA20-052B-BB68-4B99-A74FFDF34F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7257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755ED5C-DEFE-88CA-E575-4FCB2B097C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43E0674-D756-FA4E-2CF5-A5AADB333E4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01DA2B-DC35-B439-1AD0-0A23839FE3F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3631DE4-C3B3-418B-89F2-0E708D5F295C}" type="datetimeFigureOut">
              <a:rPr lang="en-US" smtClean="0"/>
              <a:t>8/13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A4782F-AE0D-07FD-1BE9-7FAEB6C67A9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BF52D3-35D5-2967-ADD3-DE9EAF2D693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92DA103-3998-486D-9EA1-C1824D05AECA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50595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close up of a leaf&#10;&#10;Description automatically generated">
            <a:extLst>
              <a:ext uri="{FF2B5EF4-FFF2-40B4-BE49-F238E27FC236}">
                <a16:creationId xmlns:a16="http://schemas.microsoft.com/office/drawing/2014/main" id="{7C8DE380-4A1A-ACB4-E82F-EB675D5EBC5B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8573" b="11403"/>
          <a:stretch/>
        </p:blipFill>
        <p:spPr>
          <a:xfrm rot="16200000">
            <a:off x="9345311" y="2014266"/>
            <a:ext cx="1991206" cy="2124616"/>
          </a:xfrm>
          <a:prstGeom prst="rect">
            <a:avLst/>
          </a:prstGeom>
        </p:spPr>
      </p:pic>
      <p:pic>
        <p:nvPicPr>
          <p:cNvPr id="11" name="Picture 10" descr="A close up of a leaf&#10;&#10;Description automatically generated">
            <a:extLst>
              <a:ext uri="{FF2B5EF4-FFF2-40B4-BE49-F238E27FC236}">
                <a16:creationId xmlns:a16="http://schemas.microsoft.com/office/drawing/2014/main" id="{7420F06A-E32F-16E0-9A25-D883693E3AC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2662" b="7313"/>
          <a:stretch/>
        </p:blipFill>
        <p:spPr>
          <a:xfrm rot="5400000">
            <a:off x="7092489" y="2014267"/>
            <a:ext cx="1991208" cy="2124616"/>
          </a:xfrm>
          <a:prstGeom prst="rect">
            <a:avLst/>
          </a:prstGeom>
        </p:spPr>
      </p:pic>
      <p:pic>
        <p:nvPicPr>
          <p:cNvPr id="14" name="Picture 13" descr="A close up of a plant&#10;&#10;Description automatically generated">
            <a:extLst>
              <a:ext uri="{FF2B5EF4-FFF2-40B4-BE49-F238E27FC236}">
                <a16:creationId xmlns:a16="http://schemas.microsoft.com/office/drawing/2014/main" id="{C2D7DDC9-BE8E-BE0E-057A-25B010F41A53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4841"/>
          <a:stretch/>
        </p:blipFill>
        <p:spPr>
          <a:xfrm rot="5400000" flipV="1">
            <a:off x="4839669" y="2014267"/>
            <a:ext cx="1991207" cy="2124615"/>
          </a:xfrm>
          <a:prstGeom prst="rect">
            <a:avLst/>
          </a:prstGeom>
        </p:spPr>
      </p:pic>
      <p:pic>
        <p:nvPicPr>
          <p:cNvPr id="16" name="Picture 15" descr="A close up of a plant&#10;&#10;Description automatically generated">
            <a:extLst>
              <a:ext uri="{FF2B5EF4-FFF2-40B4-BE49-F238E27FC236}">
                <a16:creationId xmlns:a16="http://schemas.microsoft.com/office/drawing/2014/main" id="{5CB0C83E-5ED6-647C-B760-5C091ABF6AD9}"/>
              </a:ext>
            </a:extLst>
          </p:cNvPr>
          <p:cNvPicPr>
            <a:picLocks noChangeAspect="1"/>
          </p:cNvPicPr>
          <p:nvPr/>
        </p:nvPicPr>
        <p:blipFill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86701" y="2329872"/>
            <a:ext cx="1991206" cy="1493404"/>
          </a:xfrm>
          <a:prstGeom prst="rect">
            <a:avLst/>
          </a:prstGeom>
        </p:spPr>
      </p:pic>
      <p:pic>
        <p:nvPicPr>
          <p:cNvPr id="17" name="Picture 16" descr="Close up of a plant&#10;&#10;Description automatically generated">
            <a:extLst>
              <a:ext uri="{FF2B5EF4-FFF2-40B4-BE49-F238E27FC236}">
                <a16:creationId xmlns:a16="http://schemas.microsoft.com/office/drawing/2014/main" id="{D0550BFB-19D0-9A30-9614-B6F3D0A6951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918" b="5921"/>
          <a:stretch/>
        </p:blipFill>
        <p:spPr>
          <a:xfrm rot="5400000">
            <a:off x="2505382" y="1932803"/>
            <a:ext cx="1991207" cy="2287547"/>
          </a:xfrm>
          <a:prstGeom prst="rect">
            <a:avLst/>
          </a:prstGeom>
        </p:spPr>
      </p:pic>
      <p:sp>
        <p:nvSpPr>
          <p:cNvPr id="8" name="CuadroTexto 3">
            <a:extLst>
              <a:ext uri="{FF2B5EF4-FFF2-40B4-BE49-F238E27FC236}">
                <a16:creationId xmlns:a16="http://schemas.microsoft.com/office/drawing/2014/main" id="{8E5080EB-DC3D-F792-C1B6-9295FB59C127}"/>
              </a:ext>
            </a:extLst>
          </p:cNvPr>
          <p:cNvSpPr txBox="1"/>
          <p:nvPr/>
        </p:nvSpPr>
        <p:spPr>
          <a:xfrm>
            <a:off x="0" y="0"/>
            <a:ext cx="12174166" cy="523220"/>
          </a:xfrm>
          <a:prstGeom prst="rect">
            <a:avLst/>
          </a:prstGeom>
        </p:spPr>
        <p:txBody>
          <a:bodyPr wrap="square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sz="1400" b="1" dirty="0">
                <a:solidFill>
                  <a:prstClr val="black"/>
                </a:solidFill>
                <a:latin typeface="Calibri" panose="020F0502020204030204"/>
              </a:rPr>
              <a:t>Figure S5. </a:t>
            </a:r>
            <a:r>
              <a:rPr lang="en-US" sz="1400" dirty="0">
                <a:solidFill>
                  <a:prstClr val="black"/>
                </a:solidFill>
                <a:latin typeface="Calibri" panose="020F0502020204030204"/>
              </a:rPr>
              <a:t>Symptoms induced after mechanical inoculation of </a:t>
            </a:r>
            <a:r>
              <a:rPr lang="en-US" sz="1400" dirty="0" err="1">
                <a:solidFill>
                  <a:prstClr val="black"/>
                </a:solidFill>
                <a:latin typeface="Calibri" panose="020F0502020204030204"/>
              </a:rPr>
              <a:t>ToLCNDV</a:t>
            </a:r>
            <a:r>
              <a:rPr lang="en-US" sz="1400" dirty="0">
                <a:solidFill>
                  <a:prstClr val="black"/>
                </a:solidFill>
                <a:latin typeface="Calibri" panose="020F0502020204030204"/>
              </a:rPr>
              <a:t> in F</a:t>
            </a:r>
            <a:r>
              <a:rPr lang="en-US" sz="1400" baseline="-25000" dirty="0">
                <a:solidFill>
                  <a:prstClr val="black"/>
                </a:solidFill>
                <a:latin typeface="Calibri" panose="020F0502020204030204"/>
              </a:rPr>
              <a:t>2</a:t>
            </a:r>
            <a:r>
              <a:rPr lang="en-US" sz="1400" dirty="0">
                <a:solidFill>
                  <a:prstClr val="black"/>
                </a:solidFill>
                <a:latin typeface="Calibri" panose="020F0502020204030204"/>
              </a:rPr>
              <a:t> plants derived from the initial cross PI </a:t>
            </a:r>
            <a:r>
              <a:rPr lang="en-US" sz="1400">
                <a:solidFill>
                  <a:prstClr val="black"/>
                </a:solidFill>
                <a:latin typeface="Calibri" panose="020F0502020204030204"/>
              </a:rPr>
              <a:t>414723 × </a:t>
            </a:r>
            <a:r>
              <a:rPr lang="en-US" sz="1400" dirty="0">
                <a:solidFill>
                  <a:prstClr val="black"/>
                </a:solidFill>
                <a:latin typeface="Calibri" panose="020F0502020204030204"/>
              </a:rPr>
              <a:t>BL. Symptoms were assessed by visual evaluation using an ordinal scale : 0, absence of symptoms; 1, mild symptoms; 2, moderate symptoms; 3, severe symptoms; 4, very severe symptoms</a:t>
            </a:r>
            <a:endParaRPr lang="en-GB" sz="1400" dirty="0">
              <a:solidFill>
                <a:prstClr val="black"/>
              </a:solidFill>
              <a:latin typeface="Calibri" panose="020F0502020204030204"/>
            </a:endParaRPr>
          </a:p>
        </p:txBody>
      </p:sp>
      <p:sp>
        <p:nvSpPr>
          <p:cNvPr id="2" name="CuadroTexto 1"/>
          <p:cNvSpPr txBox="1"/>
          <p:nvPr/>
        </p:nvSpPr>
        <p:spPr>
          <a:xfrm>
            <a:off x="1275465" y="1330368"/>
            <a:ext cx="385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0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3500985" y="1330368"/>
            <a:ext cx="385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1</a:t>
            </a:r>
          </a:p>
        </p:txBody>
      </p:sp>
      <p:sp>
        <p:nvSpPr>
          <p:cNvPr id="12" name="CuadroTexto 11"/>
          <p:cNvSpPr txBox="1"/>
          <p:nvPr/>
        </p:nvSpPr>
        <p:spPr>
          <a:xfrm>
            <a:off x="7952025" y="1330368"/>
            <a:ext cx="385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3</a:t>
            </a:r>
          </a:p>
        </p:txBody>
      </p:sp>
      <p:sp>
        <p:nvSpPr>
          <p:cNvPr id="13" name="CuadroTexto 12"/>
          <p:cNvSpPr txBox="1"/>
          <p:nvPr/>
        </p:nvSpPr>
        <p:spPr>
          <a:xfrm>
            <a:off x="5726505" y="1330368"/>
            <a:ext cx="385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2</a:t>
            </a:r>
          </a:p>
        </p:txBody>
      </p:sp>
      <p:sp>
        <p:nvSpPr>
          <p:cNvPr id="18" name="CuadroTexto 17"/>
          <p:cNvSpPr txBox="1"/>
          <p:nvPr/>
        </p:nvSpPr>
        <p:spPr>
          <a:xfrm>
            <a:off x="10177544" y="1330368"/>
            <a:ext cx="38548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dirty="0"/>
              <a:t>4</a:t>
            </a:r>
          </a:p>
        </p:txBody>
      </p:sp>
    </p:spTree>
    <p:extLst>
      <p:ext uri="{BB962C8B-B14F-4D97-AF65-F5344CB8AC3E}">
        <p14:creationId xmlns:p14="http://schemas.microsoft.com/office/powerpoint/2010/main" val="1399125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9</TotalTime>
  <Words>65</Words>
  <Application>Microsoft Office PowerPoint</Application>
  <PresentationFormat>Panorámica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Cristina Sáez Sánchez</dc:creator>
  <cp:lastModifiedBy>Clara Perez Moro</cp:lastModifiedBy>
  <cp:revision>5</cp:revision>
  <dcterms:created xsi:type="dcterms:W3CDTF">2024-08-05T10:05:00Z</dcterms:created>
  <dcterms:modified xsi:type="dcterms:W3CDTF">2024-08-13T17:17:49Z</dcterms:modified>
</cp:coreProperties>
</file>